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97" r:id="rId2"/>
    <p:sldId id="296" r:id="rId3"/>
    <p:sldId id="298" r:id="rId4"/>
    <p:sldId id="299" r:id="rId5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822" userDrawn="1">
          <p15:clr>
            <a:srgbClr val="A4A3A4"/>
          </p15:clr>
        </p15:guide>
        <p15:guide id="4" pos="300">
          <p15:clr>
            <a:srgbClr val="A4A3A4"/>
          </p15:clr>
        </p15:guide>
        <p15:guide id="5" pos="1325" userDrawn="1">
          <p15:clr>
            <a:srgbClr val="A4A3A4"/>
          </p15:clr>
        </p15:guide>
        <p15:guide id="9" orient="horz" pos="4785" userDrawn="1">
          <p15:clr>
            <a:srgbClr val="A4A3A4"/>
          </p15:clr>
        </p15:guide>
        <p15:guide id="10" orient="horz" pos="5375" userDrawn="1">
          <p15:clr>
            <a:srgbClr val="A4A3A4"/>
          </p15:clr>
        </p15:guide>
        <p15:guide id="15" pos="2523" userDrawn="1">
          <p15:clr>
            <a:srgbClr val="A4A3A4"/>
          </p15:clr>
        </p15:guide>
        <p15:guide id="18" orient="horz" pos="6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400" autoAdjust="0"/>
  </p:normalViewPr>
  <p:slideViewPr>
    <p:cSldViewPr showGuides="1">
      <p:cViewPr varScale="1">
        <p:scale>
          <a:sx n="72" d="100"/>
          <a:sy n="72" d="100"/>
        </p:scale>
        <p:origin x="1158" y="66"/>
      </p:cViewPr>
      <p:guideLst>
        <p:guide orient="horz" pos="3822"/>
        <p:guide pos="300"/>
        <p:guide pos="1325"/>
        <p:guide orient="horz" pos="4785"/>
        <p:guide orient="horz" pos="5375"/>
        <p:guide pos="2523"/>
        <p:guide orient="horz" pos="61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30B06A-B2B0-4F14-A906-037B7F2AACEC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BE9383-287F-46D5-B55D-B315AEF5A2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36216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A74122-AFC4-4EAB-9568-B35CD4EE3A38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03B5E-2155-4482-946F-0A34118A19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75636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F03B5E-2155-4482-946F-0A34118A1928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17806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F03B5E-2155-4482-946F-0A34118A1928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860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69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2448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9907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8407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538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975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2431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9086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1196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5813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2920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5E934-102B-496E-BC44-FD1013213E64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583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/>
          <p:cNvGraphicFramePr>
            <a:graphicFrameLocks/>
          </p:cNvGraphicFramePr>
          <p:nvPr>
            <p:extLst/>
          </p:nvPr>
        </p:nvGraphicFramePr>
        <p:xfrm>
          <a:off x="429076" y="1250460"/>
          <a:ext cx="4320000" cy="14540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34" name="Prism 5" r:id="rId4" imgW="9504000" imgH="3348000" progId="Prism5.Document">
                  <p:embed/>
                </p:oleObj>
              </mc:Choice>
              <mc:Fallback>
                <p:oleObj name="Prism 5" r:id="rId4" imgW="9504000" imgH="3348000" progId="Prism5.Document">
                  <p:embed/>
                  <p:pic>
                    <p:nvPicPr>
                      <p:cNvPr id="4" name="개체 3"/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9076" y="1250460"/>
                        <a:ext cx="4320000" cy="14540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/>
          <p:cNvGraphicFramePr>
            <a:graphicFrameLocks/>
          </p:cNvGraphicFramePr>
          <p:nvPr>
            <p:extLst/>
          </p:nvPr>
        </p:nvGraphicFramePr>
        <p:xfrm>
          <a:off x="4749556" y="1288187"/>
          <a:ext cx="1368000" cy="13573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35" name="Prism Project" r:id="rId6" imgW="2520000" imgH="2592000" progId="Prism5.Document">
                  <p:embed/>
                </p:oleObj>
              </mc:Choice>
              <mc:Fallback>
                <p:oleObj name="Prism Project" r:id="rId6" imgW="2520000" imgH="2592000" progId="Prism5.Document">
                  <p:embed/>
                  <p:pic>
                    <p:nvPicPr>
                      <p:cNvPr id="5" name="개체 4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49556" y="1288187"/>
                        <a:ext cx="1368000" cy="135734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개체 34"/>
          <p:cNvGraphicFramePr>
            <a:graphicFrameLocks/>
          </p:cNvGraphicFramePr>
          <p:nvPr>
            <p:extLst/>
          </p:nvPr>
        </p:nvGraphicFramePr>
        <p:xfrm>
          <a:off x="3286006" y="3296615"/>
          <a:ext cx="1368000" cy="13344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36" name="Prism Project" r:id="rId8" imgW="2520000" imgH="2592000" progId="Prism5.Document">
                  <p:embed/>
                </p:oleObj>
              </mc:Choice>
              <mc:Fallback>
                <p:oleObj name="Prism Project" r:id="rId8" imgW="2520000" imgH="2592000" progId="Prism5.Document">
                  <p:embed/>
                  <p:pic>
                    <p:nvPicPr>
                      <p:cNvPr id="35" name="개체 34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86006" y="3296615"/>
                        <a:ext cx="1368000" cy="133446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개체 35"/>
          <p:cNvGraphicFramePr>
            <a:graphicFrameLocks/>
          </p:cNvGraphicFramePr>
          <p:nvPr>
            <p:extLst/>
          </p:nvPr>
        </p:nvGraphicFramePr>
        <p:xfrm>
          <a:off x="459196" y="3248775"/>
          <a:ext cx="2808000" cy="14394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37" name="Prism Project" r:id="rId10" imgW="6444000" imgH="3420000" progId="Prism5.Document">
                  <p:embed/>
                </p:oleObj>
              </mc:Choice>
              <mc:Fallback>
                <p:oleObj name="Prism Project" r:id="rId10" imgW="6444000" imgH="3420000" progId="Prism5.Document">
                  <p:embed/>
                  <p:pic>
                    <p:nvPicPr>
                      <p:cNvPr id="36" name="개체 35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9196" y="3248775"/>
                        <a:ext cx="2808000" cy="143942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/>
          <p:cNvSpPr txBox="1"/>
          <p:nvPr/>
        </p:nvSpPr>
        <p:spPr>
          <a:xfrm>
            <a:off x="889152" y="3682546"/>
            <a:ext cx="497258" cy="203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###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572503" y="3891987"/>
            <a:ext cx="211573" cy="2620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293205" y="3508287"/>
            <a:ext cx="305650" cy="203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##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2" name="개체 61"/>
          <p:cNvGraphicFramePr>
            <a:graphicFrameLocks/>
          </p:cNvGraphicFramePr>
          <p:nvPr>
            <p:extLst/>
          </p:nvPr>
        </p:nvGraphicFramePr>
        <p:xfrm>
          <a:off x="489344" y="5282908"/>
          <a:ext cx="2808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38" name="Prism Project" r:id="rId12" imgW="6552000" imgH="3492000" progId="Prism5.Document">
                  <p:embed/>
                </p:oleObj>
              </mc:Choice>
              <mc:Fallback>
                <p:oleObj name="Prism Project" r:id="rId12" imgW="6552000" imgH="3492000" progId="Prism5.Document">
                  <p:embed/>
                  <p:pic>
                    <p:nvPicPr>
                      <p:cNvPr id="62" name="개체 61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9344" y="5282908"/>
                        <a:ext cx="2808000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개체 62"/>
          <p:cNvGraphicFramePr>
            <a:graphicFrameLocks/>
          </p:cNvGraphicFramePr>
          <p:nvPr>
            <p:extLst/>
          </p:nvPr>
        </p:nvGraphicFramePr>
        <p:xfrm>
          <a:off x="3302561" y="5334372"/>
          <a:ext cx="1368000" cy="13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39" name="Prism Project" r:id="rId14" imgW="2484000" imgH="2592000" progId="Prism5.Document">
                  <p:embed/>
                </p:oleObj>
              </mc:Choice>
              <mc:Fallback>
                <p:oleObj name="Prism Project" r:id="rId14" imgW="2484000" imgH="2592000" progId="Prism5.Document">
                  <p:embed/>
                  <p:pic>
                    <p:nvPicPr>
                      <p:cNvPr id="63" name="개체 62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02561" y="5334372"/>
                        <a:ext cx="1368000" cy="1332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4" name="TextBox 63"/>
          <p:cNvSpPr txBox="1"/>
          <p:nvPr/>
        </p:nvSpPr>
        <p:spPr>
          <a:xfrm>
            <a:off x="2339904" y="5605170"/>
            <a:ext cx="30212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#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702977" y="5467969"/>
            <a:ext cx="36867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###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80281" y="125234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80281" y="32217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>
              <a:defRPr sz="16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altLang="ko-KR" sz="1200" dirty="0" smtClean="0"/>
              <a:t>B</a:t>
            </a:r>
            <a:endParaRPr lang="ko-KR" alt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E8F7258-8866-9CE2-7A23-7E193453F37A}"/>
              </a:ext>
            </a:extLst>
          </p:cNvPr>
          <p:cNvSpPr txBox="1"/>
          <p:nvPr/>
        </p:nvSpPr>
        <p:spPr>
          <a:xfrm>
            <a:off x="1051857" y="1288187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Col1a1</a:t>
            </a:r>
            <a:endParaRPr lang="ko-KR" altLang="en-US" sz="800" b="1" i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EFE12DC-B4F4-DE14-994C-6600FF7C3FD9}"/>
              </a:ext>
            </a:extLst>
          </p:cNvPr>
          <p:cNvSpPr txBox="1"/>
          <p:nvPr/>
        </p:nvSpPr>
        <p:spPr>
          <a:xfrm>
            <a:off x="2399697" y="1288187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Fn1</a:t>
            </a:r>
            <a:endParaRPr lang="ko-KR" altLang="en-US" sz="800" b="1" i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78B8A3D-C39D-1921-5F47-55A2ED671266}"/>
              </a:ext>
            </a:extLst>
          </p:cNvPr>
          <p:cNvSpPr txBox="1"/>
          <p:nvPr/>
        </p:nvSpPr>
        <p:spPr>
          <a:xfrm>
            <a:off x="3866051" y="1288187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Acta2</a:t>
            </a:r>
            <a:endParaRPr lang="ko-KR" altLang="en-US" sz="800" b="1" i="1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3652E0E-D08C-3D98-A451-A78DC6674FE8}"/>
              </a:ext>
            </a:extLst>
          </p:cNvPr>
          <p:cNvSpPr txBox="1"/>
          <p:nvPr/>
        </p:nvSpPr>
        <p:spPr>
          <a:xfrm>
            <a:off x="5254408" y="1288187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Col3a1</a:t>
            </a:r>
            <a:endParaRPr lang="ko-KR" altLang="en-US" sz="800" b="1" i="1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CD65F89F-76E5-78A1-8304-9A1BB22CFD03}"/>
              </a:ext>
            </a:extLst>
          </p:cNvPr>
          <p:cNvSpPr txBox="1"/>
          <p:nvPr/>
        </p:nvSpPr>
        <p:spPr>
          <a:xfrm>
            <a:off x="966742" y="3295634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err="1"/>
              <a:t>Tnfa</a:t>
            </a:r>
            <a:endParaRPr lang="ko-KR" altLang="en-US" sz="800" b="1" i="1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DE962927-0E5B-6122-B852-B68405AF927C}"/>
              </a:ext>
            </a:extLst>
          </p:cNvPr>
          <p:cNvSpPr txBox="1"/>
          <p:nvPr/>
        </p:nvSpPr>
        <p:spPr>
          <a:xfrm>
            <a:off x="2377191" y="3295634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Tgfb1</a:t>
            </a:r>
            <a:endParaRPr lang="ko-KR" altLang="en-US" sz="800" b="1" i="1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AB618FB3-1C29-10C2-706E-E8CE8979D658}"/>
              </a:ext>
            </a:extLst>
          </p:cNvPr>
          <p:cNvSpPr txBox="1"/>
          <p:nvPr/>
        </p:nvSpPr>
        <p:spPr>
          <a:xfrm>
            <a:off x="3789299" y="3295634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Ccn2</a:t>
            </a:r>
            <a:endParaRPr lang="ko-KR" altLang="en-US" sz="800" b="1" i="1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EFE7BCB-F947-D106-2228-55BABBA04606}"/>
              </a:ext>
            </a:extLst>
          </p:cNvPr>
          <p:cNvSpPr txBox="1"/>
          <p:nvPr/>
        </p:nvSpPr>
        <p:spPr>
          <a:xfrm>
            <a:off x="1002034" y="5292660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Mmp2</a:t>
            </a:r>
            <a:endParaRPr lang="ko-KR" altLang="en-US" sz="800" b="1" i="1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CB4F54B-973A-8B63-5567-85F732B85816}"/>
              </a:ext>
            </a:extLst>
          </p:cNvPr>
          <p:cNvSpPr txBox="1"/>
          <p:nvPr/>
        </p:nvSpPr>
        <p:spPr>
          <a:xfrm>
            <a:off x="2404914" y="5292660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Mmp9</a:t>
            </a:r>
            <a:endParaRPr lang="ko-KR" altLang="en-US" sz="800" b="1" i="1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2E8D2EF6-798C-4207-77C3-E02276D32F5C}"/>
              </a:ext>
            </a:extLst>
          </p:cNvPr>
          <p:cNvSpPr txBox="1"/>
          <p:nvPr/>
        </p:nvSpPr>
        <p:spPr>
          <a:xfrm>
            <a:off x="3844332" y="5292660"/>
            <a:ext cx="523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Timp1</a:t>
            </a:r>
            <a:endParaRPr lang="ko-KR" altLang="en-US" sz="800" b="1" i="1" dirty="0"/>
          </a:p>
        </p:txBody>
      </p:sp>
      <p:grpSp>
        <p:nvGrpSpPr>
          <p:cNvPr id="2" name="그룹 1"/>
          <p:cNvGrpSpPr/>
          <p:nvPr/>
        </p:nvGrpSpPr>
        <p:grpSpPr>
          <a:xfrm>
            <a:off x="4801950" y="2476431"/>
            <a:ext cx="1355309" cy="323547"/>
            <a:chOff x="4801950" y="2476431"/>
            <a:chExt cx="1355309" cy="323547"/>
          </a:xfrm>
        </p:grpSpPr>
        <p:sp>
          <p:nvSpPr>
            <p:cNvPr id="96" name="TextBox 95"/>
            <p:cNvSpPr txBox="1"/>
            <p:nvPr/>
          </p:nvSpPr>
          <p:spPr>
            <a:xfrm rot="19733773">
              <a:off x="4826654" y="2510346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 rot="19733773">
              <a:off x="5101973" y="2476431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 rot="19733773">
              <a:off x="4801950" y="2611454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 rot="19733773">
              <a:off x="5126802" y="2612999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9733773">
              <a:off x="5286508" y="26153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 rot="19733773">
              <a:off x="4963866" y="2607663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2" name="그룹 101"/>
          <p:cNvGrpSpPr/>
          <p:nvPr/>
        </p:nvGrpSpPr>
        <p:grpSpPr>
          <a:xfrm>
            <a:off x="548680" y="2478389"/>
            <a:ext cx="1355309" cy="323547"/>
            <a:chOff x="4801950" y="2476431"/>
            <a:chExt cx="1355309" cy="323547"/>
          </a:xfrm>
        </p:grpSpPr>
        <p:sp>
          <p:nvSpPr>
            <p:cNvPr id="103" name="TextBox 102"/>
            <p:cNvSpPr txBox="1"/>
            <p:nvPr/>
          </p:nvSpPr>
          <p:spPr>
            <a:xfrm rot="19733773">
              <a:off x="4826654" y="2510346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 rot="19733773">
              <a:off x="5101973" y="2476431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 rot="19733773">
              <a:off x="4801950" y="2611454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 rot="19733773">
              <a:off x="5126802" y="2612999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 rot="19733773">
              <a:off x="5286508" y="26153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 rot="19733773">
              <a:off x="4963866" y="2607663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9" name="그룹 108"/>
          <p:cNvGrpSpPr/>
          <p:nvPr/>
        </p:nvGrpSpPr>
        <p:grpSpPr>
          <a:xfrm>
            <a:off x="1935054" y="2483768"/>
            <a:ext cx="1355309" cy="323547"/>
            <a:chOff x="4801950" y="2476431"/>
            <a:chExt cx="1355309" cy="323547"/>
          </a:xfrm>
        </p:grpSpPr>
        <p:sp>
          <p:nvSpPr>
            <p:cNvPr id="110" name="TextBox 109"/>
            <p:cNvSpPr txBox="1"/>
            <p:nvPr/>
          </p:nvSpPr>
          <p:spPr>
            <a:xfrm rot="19733773">
              <a:off x="4826654" y="2510346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9733773">
              <a:off x="5101973" y="2476431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 rot="19733773">
              <a:off x="4801950" y="2611454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 rot="19733773">
              <a:off x="5126802" y="2612999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 rot="19733773">
              <a:off x="5286508" y="26153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 rot="19733773">
              <a:off x="4963866" y="2607663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6" name="그룹 115"/>
          <p:cNvGrpSpPr/>
          <p:nvPr/>
        </p:nvGrpSpPr>
        <p:grpSpPr>
          <a:xfrm>
            <a:off x="3380593" y="2478389"/>
            <a:ext cx="1355309" cy="323547"/>
            <a:chOff x="4801950" y="2476431"/>
            <a:chExt cx="1355309" cy="323547"/>
          </a:xfrm>
        </p:grpSpPr>
        <p:sp>
          <p:nvSpPr>
            <p:cNvPr id="117" name="TextBox 116"/>
            <p:cNvSpPr txBox="1"/>
            <p:nvPr/>
          </p:nvSpPr>
          <p:spPr>
            <a:xfrm rot="19733773">
              <a:off x="4826654" y="2510346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 rot="19733773">
              <a:off x="5101973" y="2476431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 rot="19733773">
              <a:off x="4801950" y="2611454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 rot="19733773">
              <a:off x="5126802" y="2612999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 rot="19733773">
              <a:off x="5286508" y="26153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 rot="19733773">
              <a:off x="4963866" y="2607663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37" name="그룹 136"/>
          <p:cNvGrpSpPr/>
          <p:nvPr/>
        </p:nvGrpSpPr>
        <p:grpSpPr>
          <a:xfrm>
            <a:off x="527458" y="4469944"/>
            <a:ext cx="1344551" cy="323547"/>
            <a:chOff x="527458" y="4469944"/>
            <a:chExt cx="1344551" cy="323547"/>
          </a:xfrm>
        </p:grpSpPr>
        <p:sp>
          <p:nvSpPr>
            <p:cNvPr id="124" name="TextBox 123"/>
            <p:cNvSpPr txBox="1"/>
            <p:nvPr/>
          </p:nvSpPr>
          <p:spPr>
            <a:xfrm rot="19733773">
              <a:off x="568299" y="4503859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 rot="19733773">
              <a:off x="827481" y="4469944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 rot="19733773">
              <a:off x="527458" y="4604967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 rot="19733773">
              <a:off x="841552" y="46065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 rot="19733773">
              <a:off x="1001258" y="4608825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 rot="19733773">
              <a:off x="689374" y="4601176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30" name="그룹 129"/>
          <p:cNvGrpSpPr/>
          <p:nvPr/>
        </p:nvGrpSpPr>
        <p:grpSpPr>
          <a:xfrm>
            <a:off x="3346111" y="4471832"/>
            <a:ext cx="1355309" cy="323547"/>
            <a:chOff x="4801950" y="2476431"/>
            <a:chExt cx="1355309" cy="323547"/>
          </a:xfrm>
        </p:grpSpPr>
        <p:sp>
          <p:nvSpPr>
            <p:cNvPr id="131" name="TextBox 130"/>
            <p:cNvSpPr txBox="1"/>
            <p:nvPr/>
          </p:nvSpPr>
          <p:spPr>
            <a:xfrm rot="19733773">
              <a:off x="4826654" y="2510346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 rot="19733773">
              <a:off x="5101973" y="2476431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 rot="19733773">
              <a:off x="4801950" y="2611454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 rot="19733773">
              <a:off x="5126802" y="2612999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 rot="19733773">
              <a:off x="5286508" y="26153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 rot="19733773">
              <a:off x="4963866" y="2607663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45" name="그룹 144"/>
          <p:cNvGrpSpPr/>
          <p:nvPr/>
        </p:nvGrpSpPr>
        <p:grpSpPr>
          <a:xfrm>
            <a:off x="1913538" y="4473097"/>
            <a:ext cx="1344551" cy="323547"/>
            <a:chOff x="527458" y="4469944"/>
            <a:chExt cx="1344551" cy="323547"/>
          </a:xfrm>
        </p:grpSpPr>
        <p:sp>
          <p:nvSpPr>
            <p:cNvPr id="146" name="TextBox 145"/>
            <p:cNvSpPr txBox="1"/>
            <p:nvPr/>
          </p:nvSpPr>
          <p:spPr>
            <a:xfrm rot="19733773">
              <a:off x="568299" y="4503859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 rot="19733773">
              <a:off x="827481" y="4469944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 rot="19733773">
              <a:off x="527458" y="4604967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 rot="19733773">
              <a:off x="841552" y="46065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 rot="19733773">
              <a:off x="1001258" y="4608825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 rot="19733773">
              <a:off x="689374" y="4601176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52" name="그룹 151"/>
          <p:cNvGrpSpPr/>
          <p:nvPr/>
        </p:nvGrpSpPr>
        <p:grpSpPr>
          <a:xfrm>
            <a:off x="527706" y="6509977"/>
            <a:ext cx="1344551" cy="323547"/>
            <a:chOff x="527458" y="4469944"/>
            <a:chExt cx="1344551" cy="323547"/>
          </a:xfrm>
        </p:grpSpPr>
        <p:sp>
          <p:nvSpPr>
            <p:cNvPr id="153" name="TextBox 152"/>
            <p:cNvSpPr txBox="1"/>
            <p:nvPr/>
          </p:nvSpPr>
          <p:spPr>
            <a:xfrm rot="19733773">
              <a:off x="568299" y="4503859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 rot="19733773">
              <a:off x="827481" y="4469944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 rot="19733773">
              <a:off x="527458" y="4604967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 rot="19733773">
              <a:off x="841552" y="46065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 rot="19733773">
              <a:off x="1001258" y="4608825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 rot="19733773">
              <a:off x="689374" y="4601176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59" name="그룹 158"/>
          <p:cNvGrpSpPr/>
          <p:nvPr/>
        </p:nvGrpSpPr>
        <p:grpSpPr>
          <a:xfrm>
            <a:off x="1938622" y="6507891"/>
            <a:ext cx="1344551" cy="323547"/>
            <a:chOff x="527458" y="4469944"/>
            <a:chExt cx="1344551" cy="323547"/>
          </a:xfrm>
        </p:grpSpPr>
        <p:sp>
          <p:nvSpPr>
            <p:cNvPr id="160" name="TextBox 159"/>
            <p:cNvSpPr txBox="1"/>
            <p:nvPr/>
          </p:nvSpPr>
          <p:spPr>
            <a:xfrm rot="19733773">
              <a:off x="568299" y="4503859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 rot="19733773">
              <a:off x="827481" y="4469944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 rot="19733773">
              <a:off x="527458" y="4604967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 rot="19733773">
              <a:off x="841552" y="46065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 rot="19733773">
              <a:off x="1001258" y="4608825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 rot="19733773">
              <a:off x="689374" y="4601176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66" name="그룹 165"/>
          <p:cNvGrpSpPr/>
          <p:nvPr/>
        </p:nvGrpSpPr>
        <p:grpSpPr>
          <a:xfrm>
            <a:off x="3347117" y="6509977"/>
            <a:ext cx="1344551" cy="323547"/>
            <a:chOff x="527458" y="4469944"/>
            <a:chExt cx="1344551" cy="323547"/>
          </a:xfrm>
        </p:grpSpPr>
        <p:sp>
          <p:nvSpPr>
            <p:cNvPr id="167" name="TextBox 166"/>
            <p:cNvSpPr txBox="1"/>
            <p:nvPr/>
          </p:nvSpPr>
          <p:spPr>
            <a:xfrm rot="19733773">
              <a:off x="568299" y="4503859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 rot="19733773">
              <a:off x="827481" y="4469944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SS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 rot="19733773">
              <a:off x="527458" y="4604967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 rot="19733773">
              <a:off x="841552" y="4606512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1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 rot="19733773">
              <a:off x="1001258" y="4608825"/>
              <a:ext cx="8707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C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 rot="19733773">
              <a:off x="689374" y="4601176"/>
              <a:ext cx="8563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L-MSC-CM-Exp.2</a:t>
              </a:r>
              <a:endParaRPr lang="ko-KR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8" name="TextBox 137"/>
          <p:cNvSpPr txBox="1"/>
          <p:nvPr/>
        </p:nvSpPr>
        <p:spPr>
          <a:xfrm>
            <a:off x="260648" y="497766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. S</a:t>
            </a:r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4174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0" y="1543050"/>
            <a:ext cx="6669088" cy="2524894"/>
            <a:chOff x="0" y="1543050"/>
            <a:chExt cx="6669088" cy="2524894"/>
          </a:xfrm>
        </p:grpSpPr>
        <p:graphicFrame>
          <p:nvGraphicFramePr>
            <p:cNvPr id="6" name="개체 5"/>
            <p:cNvGraphicFramePr>
              <a:graphicFrameLocks noChangeAspect="1"/>
            </p:cNvGraphicFramePr>
            <p:nvPr>
              <p:extLst/>
            </p:nvPr>
          </p:nvGraphicFramePr>
          <p:xfrm>
            <a:off x="655638" y="1543050"/>
            <a:ext cx="6013450" cy="1622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210" name="Prism 5" r:id="rId4" imgW="9612000" imgH="2592000" progId="Prism5.Document">
                    <p:embed/>
                  </p:oleObj>
                </mc:Choice>
                <mc:Fallback>
                  <p:oleObj name="Prism 5" r:id="rId4" imgW="9612000" imgH="2592000" progId="Prism5.Document">
                    <p:embed/>
                    <p:pic>
                      <p:nvPicPr>
                        <p:cNvPr id="6" name="개체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55638" y="1543050"/>
                          <a:ext cx="6013450" cy="16224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>
              <a:off x="140485" y="2911895"/>
              <a:ext cx="964659" cy="21544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8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1(5ng/ml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0" y="3085859"/>
              <a:ext cx="1105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L-MSC-CM-1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9375" y="3547700"/>
              <a:ext cx="9557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C-MSC-CM-1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010763" y="290657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187854" y="291505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375968" y="291505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578111" y="291505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010763" y="308102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375968" y="310007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193396" y="308102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586564" y="308102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40485" y="3238259"/>
              <a:ext cx="9646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L-MSC-CM-2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40485" y="3390659"/>
              <a:ext cx="9646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L-MSC-CM-3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769390" y="29118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966895" y="29118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351913" y="29118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152517" y="29118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164023" y="308517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361286" y="308517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780896" y="308402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978159" y="308402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009988" y="323883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192621" y="323883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388284" y="323883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163248" y="324298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360511" y="324298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780121" y="32418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977384" y="32418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575371" y="3245160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009988" y="338826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192621" y="338826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388284" y="338826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163248" y="339240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360511" y="339240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584910" y="339126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977384" y="339126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772816" y="34001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63368" y="3700100"/>
              <a:ext cx="9417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C-MSC-CM-2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0765" y="3852500"/>
              <a:ext cx="10543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C-MSC-CM-3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009988" y="35464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192621" y="35464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388284" y="35464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163248" y="355062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360511" y="355062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584910" y="354948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780131" y="354948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963529" y="3559894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009988" y="36904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192621" y="36904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388284" y="36904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973058" y="369464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360511" y="369464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584910" y="369349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780131" y="369349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159819" y="37049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009988" y="38428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1192621" y="38428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388284" y="384289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973058" y="384704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168289" y="384704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584910" y="384589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780131" y="384589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351004" y="3850064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969570" y="290507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5146661" y="291355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5334775" y="291355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5536918" y="291355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969570" y="30795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5334775" y="309857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5152203" y="30795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545371" y="30795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5728197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5925702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6310720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6111324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6122830" y="308366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6320093" y="308366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5739703" y="308252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5936966" y="308252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968795" y="323733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151428" y="323733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347091" y="323733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6122055" y="32414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6319318" y="32414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5738928" y="324033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5936191" y="324033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5534178" y="3243658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968795" y="338675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5151428" y="338675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5347091" y="338675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6122055" y="339090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319318" y="339090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5543717" y="338976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5936191" y="338976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5731623" y="33986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4968795" y="35449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5151428" y="35449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5347091" y="35449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122055" y="35491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6319318" y="35491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5543717" y="354798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5738938" y="354798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5922336" y="3558392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968795" y="36889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5151428" y="36889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5347091" y="36889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5931865" y="36931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6319318" y="36931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5543717" y="36919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5738938" y="36919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6118626" y="37034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4968795" y="3841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5151428" y="3841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5347091" y="3841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931865" y="38455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6127096" y="38455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5543717" y="38443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5738938" y="38443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6309811" y="3848562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3032178" y="290507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209269" y="291355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397383" y="291355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599526" y="291355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3032178" y="30795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3397383" y="309857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3214811" y="30795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3607979" y="30795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3790805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3988310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373328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4173932" y="2910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4185438" y="308366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4382701" y="308366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3802311" y="308252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3999574" y="308252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031403" y="323733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3214036" y="323733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3409699" y="323733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4184663" y="32414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4381926" y="324147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3801536" y="324033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3998799" y="324033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3596786" y="3243658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3031403" y="338675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3214036" y="338675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3409699" y="338675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4184663" y="339090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4381926" y="3390905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3606325" y="338976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3998799" y="338976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3794231" y="33986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3031403" y="35449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3214036" y="35449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3409699" y="35449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4184663" y="35491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381926" y="354912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3606325" y="354798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3801546" y="3547981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3984944" y="3558392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3031403" y="36889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3214036" y="36889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3409699" y="36889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3994473" y="36931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4381926" y="36931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3606325" y="36919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3801546" y="36919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4181234" y="370347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3031403" y="3841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3214036" y="3841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3409699" y="3841393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3994473" y="38455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4189704" y="3845539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3606325" y="38443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3801546" y="3844397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4372419" y="3848562"/>
              <a:ext cx="212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TextBox 240"/>
            <p:cNvSpPr txBox="1"/>
            <p:nvPr/>
          </p:nvSpPr>
          <p:spPr>
            <a:xfrm>
              <a:off x="1141996" y="1796316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>
                  <a:latin typeface="Arial" pitchFamily="34" charset="0"/>
                  <a:cs typeface="Arial" pitchFamily="34" charset="0"/>
                </a:rPr>
                <a:t>###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1723867" y="241512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2301863" y="24670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3171708" y="1840206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>
                  <a:latin typeface="Arial" pitchFamily="34" charset="0"/>
                  <a:cs typeface="Arial" pitchFamily="34" charset="0"/>
                </a:rPr>
                <a:t>###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5" name="TextBox 244"/>
            <p:cNvSpPr txBox="1"/>
            <p:nvPr/>
          </p:nvSpPr>
          <p:spPr>
            <a:xfrm>
              <a:off x="3575210" y="21631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3744953" y="240049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4153206" y="207474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4322949" y="251695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9" name="TextBox 248"/>
            <p:cNvSpPr txBox="1"/>
            <p:nvPr/>
          </p:nvSpPr>
          <p:spPr>
            <a:xfrm>
              <a:off x="1355308" y="220024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1521269" y="227111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2098016" y="224916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5109751" y="1796316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>
                  <a:latin typeface="Arial" pitchFamily="34" charset="0"/>
                  <a:cs typeface="Arial" pitchFamily="34" charset="0"/>
                </a:rPr>
                <a:t>###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5682996" y="259068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6260992" y="267057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5489024" y="248771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6065771" y="240278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5293803" y="221373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5901043" y="216862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/>
                  <a:cs typeface="Times New Roman"/>
                </a:rPr>
                <a:t>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1725ADA-BBF0-DC2A-66C3-E6DC8CA0A510}"/>
              </a:ext>
            </a:extLst>
          </p:cNvPr>
          <p:cNvSpPr txBox="1"/>
          <p:nvPr/>
        </p:nvSpPr>
        <p:spPr>
          <a:xfrm>
            <a:off x="1452895" y="1624762"/>
            <a:ext cx="59070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COL1A1</a:t>
            </a:r>
            <a:endParaRPr lang="ko-KR" altLang="en-US" sz="800" b="1" i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FCF5836-7908-FF64-8C2B-B6848B496C71}"/>
              </a:ext>
            </a:extLst>
          </p:cNvPr>
          <p:cNvSpPr txBox="1"/>
          <p:nvPr/>
        </p:nvSpPr>
        <p:spPr>
          <a:xfrm>
            <a:off x="3524152" y="1624762"/>
            <a:ext cx="59070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FN1</a:t>
            </a:r>
            <a:endParaRPr lang="ko-KR" altLang="en-US" sz="800" b="1" i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1161AE1-B014-D309-D7DE-BEAF475172FF}"/>
              </a:ext>
            </a:extLst>
          </p:cNvPr>
          <p:cNvSpPr txBox="1"/>
          <p:nvPr/>
        </p:nvSpPr>
        <p:spPr>
          <a:xfrm>
            <a:off x="5449312" y="1624762"/>
            <a:ext cx="59070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/>
              <a:t>ACTA2</a:t>
            </a:r>
            <a:endParaRPr lang="ko-KR" altLang="en-US" sz="800" b="1" i="1" dirty="0"/>
          </a:p>
        </p:txBody>
      </p:sp>
      <p:sp>
        <p:nvSpPr>
          <p:cNvPr id="202" name="TextBox 201"/>
          <p:cNvSpPr txBox="1"/>
          <p:nvPr/>
        </p:nvSpPr>
        <p:spPr>
          <a:xfrm>
            <a:off x="260648" y="497766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. S2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8111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0648" y="497766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. S</a:t>
            </a:r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3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1570307" y="1907704"/>
            <a:ext cx="2878936" cy="4290594"/>
            <a:chOff x="1570307" y="1907704"/>
            <a:chExt cx="2878936" cy="4290594"/>
          </a:xfrm>
        </p:grpSpPr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3441" y="2505684"/>
              <a:ext cx="1389888" cy="59436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3535" y="3217452"/>
              <a:ext cx="1409700" cy="656844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48172" y="5506402"/>
              <a:ext cx="1469136" cy="691896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96563" y="4684253"/>
              <a:ext cx="1522476" cy="704088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3535" y="3957386"/>
              <a:ext cx="1365504" cy="576072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932376" y="3406692"/>
              <a:ext cx="320922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FN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698338" y="5787814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GAPDH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570307" y="2690925"/>
              <a:ext cx="69442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Procol1A1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744825" y="4176323"/>
              <a:ext cx="508473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l-GR" altLang="ko-KR" sz="800" b="1" dirty="0">
                  <a:latin typeface="Arial" pitchFamily="34" charset="0"/>
                  <a:cs typeface="Arial" pitchFamily="34" charset="0"/>
                </a:rPr>
                <a:t>α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SMA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34218" y="5025142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p-Smad2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80903" y="1916577"/>
              <a:ext cx="63030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L-MSC-CM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64873" y="2087221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C-MSC-CM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567844" y="2250539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898980" y="225550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479783" y="225550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192858" y="225550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562661" y="190770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190116" y="191998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908763" y="190770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486857" y="190770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567994" y="2083948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480252" y="209475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908486" y="2083948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193901" y="2083948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864873" y="2261917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8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1(5ng/ml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직사각형 39"/>
            <p:cNvSpPr/>
            <p:nvPr/>
          </p:nvSpPr>
          <p:spPr>
            <a:xfrm>
              <a:off x="2562661" y="2642787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1" name="직사각형 40"/>
            <p:cNvSpPr/>
            <p:nvPr/>
          </p:nvSpPr>
          <p:spPr>
            <a:xfrm>
              <a:off x="2525595" y="5741105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2" name="직사각형 41"/>
            <p:cNvSpPr/>
            <p:nvPr/>
          </p:nvSpPr>
          <p:spPr>
            <a:xfrm>
              <a:off x="2571315" y="3401717"/>
              <a:ext cx="1188000" cy="216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3" name="직사각형 42"/>
            <p:cNvSpPr/>
            <p:nvPr/>
          </p:nvSpPr>
          <p:spPr>
            <a:xfrm>
              <a:off x="2537025" y="4134069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직사각형 43"/>
            <p:cNvSpPr/>
            <p:nvPr/>
          </p:nvSpPr>
          <p:spPr>
            <a:xfrm>
              <a:off x="2522167" y="4998165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931152" y="3416566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5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931152" y="4169845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934099" y="5025142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925127" y="5784845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931152" y="2708798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0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6245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0648" y="497766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. S</a:t>
            </a:r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1505420" y="1802524"/>
            <a:ext cx="2921284" cy="4259965"/>
            <a:chOff x="1505420" y="1802524"/>
            <a:chExt cx="2921284" cy="4259965"/>
          </a:xfrm>
        </p:grpSpPr>
        <p:sp>
          <p:nvSpPr>
            <p:cNvPr id="6" name="TextBox 5"/>
            <p:cNvSpPr txBox="1"/>
            <p:nvPr/>
          </p:nvSpPr>
          <p:spPr>
            <a:xfrm>
              <a:off x="1893507" y="1811397"/>
              <a:ext cx="63030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L-MSC-CM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877477" y="1982041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C-MSC-CM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580448" y="2145359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11584" y="215032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492387" y="215032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205462" y="215032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575265" y="180252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202720" y="181480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921367" y="180252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499461" y="180252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580598" y="1978768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492856" y="198957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921090" y="1978768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206505" y="1978768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877477" y="2156737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8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1(5ng/ml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1" name="그림 2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56212" y="5419361"/>
              <a:ext cx="1577340" cy="643128"/>
            </a:xfrm>
            <a:prstGeom prst="rect">
              <a:avLst/>
            </a:prstGeom>
          </p:spPr>
        </p:pic>
        <p:pic>
          <p:nvPicPr>
            <p:cNvPr id="22" name="그림 2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1033" y="4053286"/>
              <a:ext cx="1438656" cy="452628"/>
            </a:xfrm>
            <a:prstGeom prst="rect">
              <a:avLst/>
            </a:prstGeom>
          </p:spPr>
        </p:pic>
        <p:pic>
          <p:nvPicPr>
            <p:cNvPr id="23" name="그림 2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00414" y="2562243"/>
              <a:ext cx="1360932" cy="577596"/>
            </a:xfrm>
            <a:prstGeom prst="rect">
              <a:avLst/>
            </a:prstGeom>
          </p:spPr>
        </p:pic>
        <p:pic>
          <p:nvPicPr>
            <p:cNvPr id="24" name="그림 2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1033" y="4749325"/>
              <a:ext cx="1481520" cy="547116"/>
            </a:xfrm>
            <a:prstGeom prst="rect">
              <a:avLst/>
            </a:prstGeom>
          </p:spPr>
        </p:pic>
        <p:sp>
          <p:nvSpPr>
            <p:cNvPr id="25" name="TextBox 64"/>
            <p:cNvSpPr txBox="1"/>
            <p:nvPr/>
          </p:nvSpPr>
          <p:spPr>
            <a:xfrm>
              <a:off x="1878919" y="3393700"/>
              <a:ext cx="320922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SRF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65"/>
            <p:cNvSpPr txBox="1"/>
            <p:nvPr/>
          </p:nvSpPr>
          <p:spPr>
            <a:xfrm>
              <a:off x="1637166" y="5603406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GAPDH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66"/>
            <p:cNvSpPr txBox="1"/>
            <p:nvPr/>
          </p:nvSpPr>
          <p:spPr>
            <a:xfrm>
              <a:off x="1505420" y="2550040"/>
              <a:ext cx="694421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MRTF-A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67"/>
            <p:cNvSpPr txBox="1"/>
            <p:nvPr/>
          </p:nvSpPr>
          <p:spPr>
            <a:xfrm>
              <a:off x="1691368" y="4132312"/>
              <a:ext cx="508473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HDAC1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82"/>
            <p:cNvSpPr txBox="1"/>
            <p:nvPr/>
          </p:nvSpPr>
          <p:spPr>
            <a:xfrm>
              <a:off x="1564135" y="5047998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800" b="1" dirty="0" err="1">
                  <a:latin typeface="Arial" pitchFamily="34" charset="0"/>
                  <a:cs typeface="Arial" pitchFamily="34" charset="0"/>
                </a:rPr>
                <a:t>RhoA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8" name="그림 3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27547" y="3202542"/>
              <a:ext cx="1190244" cy="662940"/>
            </a:xfrm>
            <a:prstGeom prst="rect">
              <a:avLst/>
            </a:prstGeom>
          </p:spPr>
        </p:pic>
        <p:sp>
          <p:nvSpPr>
            <p:cNvPr id="39" name="직사각형 38"/>
            <p:cNvSpPr/>
            <p:nvPr/>
          </p:nvSpPr>
          <p:spPr>
            <a:xfrm>
              <a:off x="2572515" y="2471362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0" name="직사각형 39"/>
            <p:cNvSpPr/>
            <p:nvPr/>
          </p:nvSpPr>
          <p:spPr>
            <a:xfrm>
              <a:off x="2533604" y="3327643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1" name="직사각형 40"/>
            <p:cNvSpPr/>
            <p:nvPr/>
          </p:nvSpPr>
          <p:spPr>
            <a:xfrm>
              <a:off x="2533604" y="5546587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2" name="직사각형 41"/>
            <p:cNvSpPr/>
            <p:nvPr/>
          </p:nvSpPr>
          <p:spPr>
            <a:xfrm>
              <a:off x="2515743" y="4068488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3" name="직사각형 42"/>
            <p:cNvSpPr/>
            <p:nvPr/>
          </p:nvSpPr>
          <p:spPr>
            <a:xfrm>
              <a:off x="2526498" y="5019255"/>
              <a:ext cx="1188000" cy="2903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908613" y="2548209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5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908208" y="3390555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920043" y="4126760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2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908208" y="5047998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917008" y="5602062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64045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19</TotalTime>
  <Words>357</Words>
  <Application>Microsoft Office PowerPoint</Application>
  <PresentationFormat>화면 슬라이드 쇼(4:3)</PresentationFormat>
  <Paragraphs>329</Paragraphs>
  <Slides>4</Slides>
  <Notes>2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맑은 고딕</vt:lpstr>
      <vt:lpstr>Arial</vt:lpstr>
      <vt:lpstr>Times New Roman</vt:lpstr>
      <vt:lpstr>Office 테마</vt:lpstr>
      <vt:lpstr>Prism 5</vt:lpstr>
      <vt:lpstr>Prism Project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cha</cp:lastModifiedBy>
  <cp:revision>829</cp:revision>
  <cp:lastPrinted>2019-05-29T04:39:50Z</cp:lastPrinted>
  <dcterms:created xsi:type="dcterms:W3CDTF">2019-05-10T05:38:40Z</dcterms:created>
  <dcterms:modified xsi:type="dcterms:W3CDTF">2024-02-07T05:22:25Z</dcterms:modified>
</cp:coreProperties>
</file>